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438" y="1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3C9756-C364-46EC-8752-0DB37978861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4CF3A2-6E9E-466C-9545-FCE8BE9117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1521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4CF3A2-6E9E-466C-9545-FCE8BE91173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34230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2176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71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2908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02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287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710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906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9783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8072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567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2861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BDEB8-25D0-4EFA-943A-2CDF2275FB36}" type="datetimeFigureOut">
              <a:rPr kumimoji="1" lang="ja-JP" altLang="en-US" smtClean="0"/>
              <a:t>2019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D2262-0165-4E51-9172-6415A2FA1B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997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2241408" y="4830534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6664016" y="4869160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820" y="1609472"/>
            <a:ext cx="4178100" cy="3221062"/>
          </a:xfrm>
          <a:prstGeom prst="rect">
            <a:avLst/>
          </a:prstGeom>
        </p:spPr>
      </p:pic>
      <p:pic>
        <p:nvPicPr>
          <p:cNvPr id="17" name="図 16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008" y="1566818"/>
            <a:ext cx="4248472" cy="3263716"/>
          </a:xfrm>
          <a:prstGeom prst="rect">
            <a:avLst/>
          </a:prstGeom>
        </p:spPr>
      </p:pic>
      <p:sp>
        <p:nvSpPr>
          <p:cNvPr id="20" name="テキスト ボックス 19"/>
          <p:cNvSpPr txBox="1"/>
          <p:nvPr/>
        </p:nvSpPr>
        <p:spPr>
          <a:xfrm>
            <a:off x="885906" y="2132856"/>
            <a:ext cx="16017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ld-type plasmid </a:t>
            </a:r>
            <a:endParaRPr kumimoji="1" lang="en-US" altLang="ja-JP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.0 log copies/mL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253783" y="2124901"/>
            <a:ext cx="17148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145A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ype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asmid 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.0 log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pies/mL</a:t>
            </a:r>
            <a:endParaRPr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885907" y="3200642"/>
            <a:ext cx="16017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 probe (FAM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231809" y="3168520"/>
            <a:ext cx="1758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145A-type probe (HEX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線矢印コネクタ 28"/>
          <p:cNvCxnSpPr/>
          <p:nvPr/>
        </p:nvCxnSpPr>
        <p:spPr>
          <a:xfrm>
            <a:off x="3491880" y="3927227"/>
            <a:ext cx="0" cy="29273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>
            <a:off x="7680560" y="3927227"/>
            <a:ext cx="0" cy="23927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/>
          <p:cNvCxnSpPr/>
          <p:nvPr/>
        </p:nvCxnSpPr>
        <p:spPr>
          <a:xfrm>
            <a:off x="6606206" y="3551459"/>
            <a:ext cx="206963" cy="22095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/>
          <p:cNvSpPr txBox="1"/>
          <p:nvPr/>
        </p:nvSpPr>
        <p:spPr>
          <a:xfrm>
            <a:off x="2508352" y="3649883"/>
            <a:ext cx="1758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145A-type probe (HEX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矢印コネクタ 30"/>
          <p:cNvCxnSpPr/>
          <p:nvPr/>
        </p:nvCxnSpPr>
        <p:spPr>
          <a:xfrm>
            <a:off x="2197907" y="3551458"/>
            <a:ext cx="206963" cy="22095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/>
          <p:cNvSpPr txBox="1"/>
          <p:nvPr/>
        </p:nvSpPr>
        <p:spPr>
          <a:xfrm>
            <a:off x="7076856" y="3665617"/>
            <a:ext cx="16017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 probe (FAM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8776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37</Words>
  <Application>Microsoft Office PowerPoint</Application>
  <PresentationFormat>画面に合わせる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ruki</dc:creator>
  <cp:lastModifiedBy>Haruki</cp:lastModifiedBy>
  <cp:revision>7</cp:revision>
  <dcterms:created xsi:type="dcterms:W3CDTF">2019-06-17T06:30:38Z</dcterms:created>
  <dcterms:modified xsi:type="dcterms:W3CDTF">2019-08-01T01:29:40Z</dcterms:modified>
</cp:coreProperties>
</file>